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659" autoAdjust="0"/>
  </p:normalViewPr>
  <p:slideViewPr>
    <p:cSldViewPr>
      <p:cViewPr varScale="1">
        <p:scale>
          <a:sx n="67" d="100"/>
          <a:sy n="67" d="100"/>
        </p:scale>
        <p:origin x="-1344" y="-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87E7F-D797-48E7-869B-EEC08EAA9255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FE2EF-5422-4ECC-A4DE-48BDD40245F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320CDB-380F-420E-8A48-7C91503F24C7}" type="slidenum">
              <a:rPr lang="zh-TW" altLang="en-US" smtClean="0"/>
              <a:pPr/>
              <a:t>1</a:t>
            </a:fld>
            <a:endParaRPr lang="zh-TW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782C5-6A5B-4ADE-BCF5-73FBA5F4E992}" type="datetimeFigureOut">
              <a:rPr lang="zh-TW" altLang="en-US" smtClean="0"/>
              <a:pPr/>
              <a:t>2014/5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7DA77-AA81-4584-95E6-7FA8A40DE4C9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39552" y="188640"/>
            <a:ext cx="7056784" cy="43771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4"/>
          <p:cNvSpPr/>
          <p:nvPr/>
        </p:nvSpPr>
        <p:spPr>
          <a:xfrm>
            <a:off x="323528" y="4725144"/>
            <a:ext cx="8118648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Supp Figure. Mean polymerase activity of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chimeric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vRNPs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of different viruses from the 27-run fractional factorial design at different temperatures. Twenty-seven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chimeric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vRNP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combinations originated from human H1N1 (H1), human H3N2 (H3) and human isolate of avian H7N9 (H7) viruses were selected from the 27-run fractional factorial design. The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chimeric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vRNPs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were reconstituted in 293T cells at 33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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C (black) and 37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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C (white). Mock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transfection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(M) and wild type H1N1, H3N2 and H7N9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vRNPs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were used as control. The polymerase activities of the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chimeric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vRNPs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were studied by </a:t>
            </a:r>
            <a:r>
              <a:rPr lang="en-US" altLang="zh-TW" sz="1400" dirty="0" err="1" smtClean="0">
                <a:latin typeface="Times New Roman" pitchFamily="18" charset="0"/>
                <a:cs typeface="Times New Roman" pitchFamily="18" charset="0"/>
              </a:rPr>
              <a:t>luciferase</a:t>
            </a:r>
            <a:r>
              <a:rPr lang="en-US" altLang="zh-TW" sz="1400" dirty="0" smtClean="0">
                <a:latin typeface="Times New Roman" pitchFamily="18" charset="0"/>
                <a:cs typeface="Times New Roman" pitchFamily="18" charset="0"/>
              </a:rPr>
              <a:t> reporter assay. The data are normalized by GFP expression and are expressed as mean polymerase activity (N=3). Error bars represent one standard deviation.</a:t>
            </a:r>
            <a:endParaRPr lang="zh-TW" altLang="en-US" sz="14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971600" y="1628800"/>
          <a:ext cx="7488831" cy="2067696"/>
        </p:xfrm>
        <a:graphic>
          <a:graphicData uri="http://schemas.openxmlformats.org/drawingml/2006/table">
            <a:tbl>
              <a:tblPr/>
              <a:tblGrid>
                <a:gridCol w="2099048"/>
                <a:gridCol w="1499480"/>
                <a:gridCol w="3890303"/>
              </a:tblGrid>
              <a:tr h="166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Arial Unicode MS"/>
                        </a:rPr>
                        <a:t>Virus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ene segement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Arial Unicode MS"/>
                        </a:rPr>
                        <a:t>Amino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Arial Unicode MS"/>
                        </a:rPr>
                        <a:t>acid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Arial Unicode MS"/>
                        </a:rPr>
                        <a:t>difference*</a:t>
                      </a:r>
                    </a:p>
                  </a:txBody>
                  <a:tcPr marL="5938" marR="5938" marT="59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A/HK/4259592/2013 (H1N1)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B2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D195N, R293K, V344M, I354L, V731I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B1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G154D, I397M, I435T, H456Y, 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A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Y161F, P224F, E252V, N321K, A343T, N350K, S421I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NP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V100I, S498N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/HK/4003076/2013 (H3N2)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B2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I63V, I133V, K353R, I461V, T613A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B1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178G, R361K, N375S, L576I, A587T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A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V308I, D396E, N409S, V668I, N675K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6255">
                <a:tc>
                  <a:txBody>
                    <a:bodyPr/>
                    <a:lstStyle/>
                    <a:p>
                      <a:pPr algn="l" fontAlgn="ctr"/>
                      <a:r>
                        <a:rPr lang="zh-TW" altLang="en-US" sz="1100" b="0" i="0" u="none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　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NP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398Q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4379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 Unicode MS"/>
                        </a:rPr>
                        <a:t>* Differences between the specified virus and its corresponding prototype strain (H1: A/CA/04/2009; H3: </a:t>
                      </a:r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Arial Unicode MS"/>
                        </a:rPr>
                        <a:t>A/HK/405595/2009).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Arial Unicode MS"/>
                      </a:endParaRP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</a:tr>
              <a:tr h="154379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 The former amino acid for each mutation represents the residue found in the corresponding prototype strain</a:t>
                      </a:r>
                    </a:p>
                  </a:txBody>
                  <a:tcPr marL="5938" marR="5938" marT="59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83568" y="1052736"/>
            <a:ext cx="8057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/>
              <a:t>Supplementary  Table 1. Amino acid differences between seasonal and prototype </a:t>
            </a:r>
            <a:r>
              <a:rPr lang="en-US" altLang="zh-TW" sz="1400" b="1" dirty="0" err="1" smtClean="0"/>
              <a:t>vRNPs</a:t>
            </a:r>
            <a:r>
              <a:rPr lang="en-US" altLang="zh-TW" sz="1400" b="1" dirty="0" smtClean="0"/>
              <a:t> used in this study</a:t>
            </a:r>
            <a:endParaRPr lang="zh-TW" altLang="en-US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6</TotalTime>
  <Words>274</Words>
  <Application>Microsoft Office PowerPoint</Application>
  <PresentationFormat>On-screen Show (4:3)</PresentationFormat>
  <Paragraphs>27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佈景主題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cdtest</dc:creator>
  <cp:lastModifiedBy>Leo</cp:lastModifiedBy>
  <cp:revision>6</cp:revision>
  <dcterms:created xsi:type="dcterms:W3CDTF">2014-03-23T15:44:42Z</dcterms:created>
  <dcterms:modified xsi:type="dcterms:W3CDTF">2014-05-26T11:06:53Z</dcterms:modified>
</cp:coreProperties>
</file>